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1" r:id="rId2"/>
  </p:sldIdLst>
  <p:sldSz cx="109728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686"/>
    <p:restoredTop sz="94583"/>
  </p:normalViewPr>
  <p:slideViewPr>
    <p:cSldViewPr snapToGrid="0" snapToObjects="1">
      <p:cViewPr varScale="1">
        <p:scale>
          <a:sx n="78" d="100"/>
          <a:sy n="78" d="100"/>
        </p:scale>
        <p:origin x="84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1496484"/>
            <a:ext cx="9326880" cy="3183467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802717"/>
            <a:ext cx="8229600" cy="2207683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289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89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486834"/>
            <a:ext cx="236601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486834"/>
            <a:ext cx="696087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02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62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2279653"/>
            <a:ext cx="9464040" cy="3803649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6119286"/>
            <a:ext cx="9464040" cy="2000249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90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2434167"/>
            <a:ext cx="46634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2434167"/>
            <a:ext cx="46634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2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486836"/>
            <a:ext cx="946404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2241551"/>
            <a:ext cx="4642008" cy="109854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3340100"/>
            <a:ext cx="464200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2241551"/>
            <a:ext cx="4664869" cy="109854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3340100"/>
            <a:ext cx="466486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98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169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67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609600"/>
            <a:ext cx="3539014" cy="21336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1316569"/>
            <a:ext cx="5554980" cy="6498167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2743200"/>
            <a:ext cx="3539014" cy="5082117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102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609600"/>
            <a:ext cx="3539014" cy="21336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1316569"/>
            <a:ext cx="5554980" cy="6498167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2743200"/>
            <a:ext cx="3539014" cy="5082117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596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486836"/>
            <a:ext cx="946404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2434167"/>
            <a:ext cx="946404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ADA6C-328B-304B-9825-4589D6D8AD18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8475136"/>
            <a:ext cx="37033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57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E6ABDEC-AF2A-E34E-9EFB-98E17CE64A5D}"/>
              </a:ext>
            </a:extLst>
          </p:cNvPr>
          <p:cNvSpPr/>
          <p:nvPr/>
        </p:nvSpPr>
        <p:spPr>
          <a:xfrm>
            <a:off x="139147" y="94926"/>
            <a:ext cx="604552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6-source data1</a:t>
            </a:r>
            <a:endParaRPr lang="en-US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6A: WDR5; p-s6K; S6K; </a:t>
            </a:r>
          </a:p>
          <a:p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-4E-BP1; 4E-BP1; Vinculin (left-6 lanes; right-4 lanes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904AFCD-45AC-1345-B16B-736FF8F365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082" r="25845"/>
          <a:stretch/>
        </p:blipFill>
        <p:spPr>
          <a:xfrm>
            <a:off x="4360476" y="1268176"/>
            <a:ext cx="3065287" cy="371060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E48AA27-095B-EA4F-AC7E-D5849BB5F907}"/>
              </a:ext>
            </a:extLst>
          </p:cNvPr>
          <p:cNvSpPr/>
          <p:nvPr/>
        </p:nvSpPr>
        <p:spPr>
          <a:xfrm>
            <a:off x="4775951" y="2619102"/>
            <a:ext cx="1311654" cy="3473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0643FAA-E889-FD4A-BC90-0C7F19856819}"/>
              </a:ext>
            </a:extLst>
          </p:cNvPr>
          <p:cNvSpPr/>
          <p:nvPr/>
        </p:nvSpPr>
        <p:spPr>
          <a:xfrm>
            <a:off x="6087605" y="2658859"/>
            <a:ext cx="874672" cy="3075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A023E2C-5494-1842-A2B7-988B2A53F7F9}"/>
              </a:ext>
            </a:extLst>
          </p:cNvPr>
          <p:cNvSpPr/>
          <p:nvPr/>
        </p:nvSpPr>
        <p:spPr>
          <a:xfrm>
            <a:off x="4802455" y="4495677"/>
            <a:ext cx="1311654" cy="3473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F9BD7BF-6D60-1A4D-8F17-757694FBDCEB}"/>
              </a:ext>
            </a:extLst>
          </p:cNvPr>
          <p:cNvSpPr/>
          <p:nvPr/>
        </p:nvSpPr>
        <p:spPr>
          <a:xfrm>
            <a:off x="6144987" y="4535434"/>
            <a:ext cx="874672" cy="3075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5247E9C-976F-384D-8341-0A27B59D85C0}"/>
              </a:ext>
            </a:extLst>
          </p:cNvPr>
          <p:cNvSpPr/>
          <p:nvPr/>
        </p:nvSpPr>
        <p:spPr>
          <a:xfrm>
            <a:off x="5052411" y="4177730"/>
            <a:ext cx="6288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4E-BP1</a:t>
            </a:r>
            <a:endParaRPr lang="en-US" sz="1200" b="1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1A79E27-AEF0-8E43-A637-DD288EE051EF}"/>
              </a:ext>
            </a:extLst>
          </p:cNvPr>
          <p:cNvSpPr/>
          <p:nvPr/>
        </p:nvSpPr>
        <p:spPr>
          <a:xfrm>
            <a:off x="5052411" y="2206339"/>
            <a:ext cx="7587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-4E-BP1</a:t>
            </a:r>
            <a:endParaRPr lang="en-US" sz="1200" b="1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9F2E32B-459E-5846-8B54-E5EF84FF3E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039" t="16283" r="19627" b="24013"/>
          <a:stretch/>
        </p:blipFill>
        <p:spPr>
          <a:xfrm>
            <a:off x="724767" y="6089653"/>
            <a:ext cx="2979988" cy="2033337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7BF08386-F857-BA44-98EC-4A83500869C2}"/>
              </a:ext>
            </a:extLst>
          </p:cNvPr>
          <p:cNvSpPr/>
          <p:nvPr/>
        </p:nvSpPr>
        <p:spPr>
          <a:xfrm>
            <a:off x="833376" y="6377790"/>
            <a:ext cx="1239264" cy="34182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4BDFFD3-26FD-6946-9EE6-F13459441EB2}"/>
              </a:ext>
            </a:extLst>
          </p:cNvPr>
          <p:cNvSpPr/>
          <p:nvPr/>
        </p:nvSpPr>
        <p:spPr>
          <a:xfrm>
            <a:off x="1174758" y="5834154"/>
            <a:ext cx="42030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6K</a:t>
            </a:r>
            <a:endParaRPr lang="en-US" sz="1200" b="1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267CBFA-B05B-D549-9121-961B2DAD76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742" t="22248" r="17473" b="12994"/>
          <a:stretch/>
        </p:blipFill>
        <p:spPr>
          <a:xfrm>
            <a:off x="724767" y="3548659"/>
            <a:ext cx="2979988" cy="2226414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1A414BB8-0884-F844-947A-2B5B1B8192A9}"/>
              </a:ext>
            </a:extLst>
          </p:cNvPr>
          <p:cNvSpPr/>
          <p:nvPr/>
        </p:nvSpPr>
        <p:spPr>
          <a:xfrm>
            <a:off x="1028396" y="3978188"/>
            <a:ext cx="1311654" cy="3473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E04C7A2-92DD-F94D-ACE1-D2E1D18D0578}"/>
              </a:ext>
            </a:extLst>
          </p:cNvPr>
          <p:cNvSpPr/>
          <p:nvPr/>
        </p:nvSpPr>
        <p:spPr>
          <a:xfrm>
            <a:off x="1279049" y="3276841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-S6K</a:t>
            </a:r>
            <a:endParaRPr lang="en-US" sz="1200" b="1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2A8B9B2-012F-BE4B-9D7F-1DD7C6CD15F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588" t="17244" r="24113" b="36382"/>
          <a:stretch/>
        </p:blipFill>
        <p:spPr>
          <a:xfrm>
            <a:off x="724767" y="1322967"/>
            <a:ext cx="3368497" cy="1953874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6D70BB6C-05FB-4D49-801B-5FB36A8816B5}"/>
              </a:ext>
            </a:extLst>
          </p:cNvPr>
          <p:cNvSpPr/>
          <p:nvPr/>
        </p:nvSpPr>
        <p:spPr>
          <a:xfrm>
            <a:off x="911205" y="2436174"/>
            <a:ext cx="1481592" cy="3473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44B46FC-031A-0043-B66D-9CBD53D4261E}"/>
              </a:ext>
            </a:extLst>
          </p:cNvPr>
          <p:cNvSpPr/>
          <p:nvPr/>
        </p:nvSpPr>
        <p:spPr>
          <a:xfrm>
            <a:off x="1279049" y="2871704"/>
            <a:ext cx="5870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DR5</a:t>
            </a:r>
            <a:endParaRPr lang="en-US" sz="1200" b="1" dirty="0"/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EE349EBF-C764-7B48-9A40-9EF37B7EA7A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7083" t="17729" r="22588" b="31546"/>
          <a:stretch/>
        </p:blipFill>
        <p:spPr>
          <a:xfrm>
            <a:off x="4327836" y="5114549"/>
            <a:ext cx="3143679" cy="2112264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36ED8AC1-5C11-744E-8059-E30DBE325B32}"/>
              </a:ext>
            </a:extLst>
          </p:cNvPr>
          <p:cNvSpPr/>
          <p:nvPr/>
        </p:nvSpPr>
        <p:spPr>
          <a:xfrm>
            <a:off x="4547206" y="5687518"/>
            <a:ext cx="1440958" cy="3473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3462C355-F441-7145-BA2B-126080970498}"/>
              </a:ext>
            </a:extLst>
          </p:cNvPr>
          <p:cNvSpPr/>
          <p:nvPr/>
        </p:nvSpPr>
        <p:spPr>
          <a:xfrm>
            <a:off x="6011781" y="5707396"/>
            <a:ext cx="950495" cy="3075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5F2EE34-A949-A249-80A6-964AE46D252F}"/>
              </a:ext>
            </a:extLst>
          </p:cNvPr>
          <p:cNvSpPr/>
          <p:nvPr/>
        </p:nvSpPr>
        <p:spPr>
          <a:xfrm>
            <a:off x="4953240" y="5378657"/>
            <a:ext cx="6864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vinculin</a:t>
            </a:r>
            <a:endParaRPr lang="en-US" sz="1200" b="1" dirty="0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9AA49461-34C3-3D43-B23B-0403C8B918A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7193" t="17661" r="22478" b="31546"/>
          <a:stretch/>
        </p:blipFill>
        <p:spPr>
          <a:xfrm>
            <a:off x="8044775" y="733692"/>
            <a:ext cx="2904032" cy="1953874"/>
          </a:xfrm>
          <a:prstGeom prst="rect">
            <a:avLst/>
          </a:prstGeom>
        </p:spPr>
      </p:pic>
      <p:sp>
        <p:nvSpPr>
          <p:cNvPr id="30" name="Rectangle 29">
            <a:extLst>
              <a:ext uri="{FF2B5EF4-FFF2-40B4-BE49-F238E27FC236}">
                <a16:creationId xmlns:a16="http://schemas.microsoft.com/office/drawing/2014/main" id="{543F6F61-EA17-504F-B485-0183D90FFDD9}"/>
              </a:ext>
            </a:extLst>
          </p:cNvPr>
          <p:cNvSpPr/>
          <p:nvPr/>
        </p:nvSpPr>
        <p:spPr>
          <a:xfrm>
            <a:off x="9580567" y="2286412"/>
            <a:ext cx="950495" cy="3075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2D992B9-5256-1649-8CEB-153917F45AEC}"/>
              </a:ext>
            </a:extLst>
          </p:cNvPr>
          <p:cNvSpPr/>
          <p:nvPr/>
        </p:nvSpPr>
        <p:spPr>
          <a:xfrm>
            <a:off x="9715740" y="1981744"/>
            <a:ext cx="5870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DR5</a:t>
            </a:r>
            <a:endParaRPr lang="en-US" sz="1200" b="1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D608556F-8343-6441-AF0B-529A14DA220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0139" r="26072"/>
          <a:stretch/>
        </p:blipFill>
        <p:spPr>
          <a:xfrm>
            <a:off x="8044775" y="2811115"/>
            <a:ext cx="2896187" cy="3589594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C63E75E4-680C-8B4B-B952-E30F3F8D8146}"/>
              </a:ext>
            </a:extLst>
          </p:cNvPr>
          <p:cNvSpPr/>
          <p:nvPr/>
        </p:nvSpPr>
        <p:spPr>
          <a:xfrm>
            <a:off x="9632485" y="5234587"/>
            <a:ext cx="898577" cy="3075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797E378-2278-D24A-B34A-E30AFB5A9244}"/>
              </a:ext>
            </a:extLst>
          </p:cNvPr>
          <p:cNvSpPr/>
          <p:nvPr/>
        </p:nvSpPr>
        <p:spPr>
          <a:xfrm>
            <a:off x="9849174" y="4937824"/>
            <a:ext cx="42030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6K</a:t>
            </a:r>
            <a:endParaRPr lang="en-US" sz="1200" b="1" dirty="0"/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95C62DA6-8188-0242-BD29-D50385C8426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0136" r="24169" b="47671"/>
          <a:stretch/>
        </p:blipFill>
        <p:spPr>
          <a:xfrm>
            <a:off x="7754735" y="6858954"/>
            <a:ext cx="2896187" cy="1814100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74B745F5-F802-3F49-ACCB-3B4568BB26FA}"/>
              </a:ext>
            </a:extLst>
          </p:cNvPr>
          <p:cNvSpPr/>
          <p:nvPr/>
        </p:nvSpPr>
        <p:spPr>
          <a:xfrm>
            <a:off x="9357360" y="7192731"/>
            <a:ext cx="817397" cy="3075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6AFE2C1-65FF-A645-B803-0717F34794B7}"/>
              </a:ext>
            </a:extLst>
          </p:cNvPr>
          <p:cNvSpPr/>
          <p:nvPr/>
        </p:nvSpPr>
        <p:spPr>
          <a:xfrm>
            <a:off x="9492869" y="6895968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-S6K</a:t>
            </a:r>
            <a:endParaRPr lang="en-US" sz="1200" b="1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3364984-E53C-6C4C-B5E9-13C5AB8A56EE}"/>
              </a:ext>
            </a:extLst>
          </p:cNvPr>
          <p:cNvSpPr txBox="1"/>
          <p:nvPr/>
        </p:nvSpPr>
        <p:spPr>
          <a:xfrm>
            <a:off x="341384" y="1539198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95FA80E-E244-E147-8B1F-3F77F2171231}"/>
              </a:ext>
            </a:extLst>
          </p:cNvPr>
          <p:cNvSpPr txBox="1"/>
          <p:nvPr/>
        </p:nvSpPr>
        <p:spPr>
          <a:xfrm>
            <a:off x="342082" y="1651225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96BAE63-7793-924B-8DEF-C4D8EFA6BB20}"/>
              </a:ext>
            </a:extLst>
          </p:cNvPr>
          <p:cNvSpPr txBox="1"/>
          <p:nvPr/>
        </p:nvSpPr>
        <p:spPr>
          <a:xfrm>
            <a:off x="420628" y="178206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A881847-F4A9-A044-B31B-D23F0025AA8B}"/>
              </a:ext>
            </a:extLst>
          </p:cNvPr>
          <p:cNvSpPr txBox="1"/>
          <p:nvPr/>
        </p:nvSpPr>
        <p:spPr>
          <a:xfrm>
            <a:off x="397036" y="207026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854CD7A-C4A9-3F47-A814-BB7198D4838A}"/>
              </a:ext>
            </a:extLst>
          </p:cNvPr>
          <p:cNvSpPr txBox="1"/>
          <p:nvPr/>
        </p:nvSpPr>
        <p:spPr>
          <a:xfrm>
            <a:off x="392024" y="233832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E169B83-1834-A24D-9F75-A99C28B734D1}"/>
              </a:ext>
            </a:extLst>
          </p:cNvPr>
          <p:cNvSpPr txBox="1"/>
          <p:nvPr/>
        </p:nvSpPr>
        <p:spPr>
          <a:xfrm>
            <a:off x="378574" y="277138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8E85C39-CD94-C243-97BF-122B2AEB5980}"/>
              </a:ext>
            </a:extLst>
          </p:cNvPr>
          <p:cNvSpPr txBox="1"/>
          <p:nvPr/>
        </p:nvSpPr>
        <p:spPr>
          <a:xfrm>
            <a:off x="357763" y="139512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B5B809A-8C31-2F4F-8842-B61CE5DEF5BE}"/>
              </a:ext>
            </a:extLst>
          </p:cNvPr>
          <p:cNvSpPr txBox="1"/>
          <p:nvPr/>
        </p:nvSpPr>
        <p:spPr>
          <a:xfrm>
            <a:off x="7696483" y="119963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8D04DAB-D660-274B-906A-C272228C1878}"/>
              </a:ext>
            </a:extLst>
          </p:cNvPr>
          <p:cNvSpPr txBox="1"/>
          <p:nvPr/>
        </p:nvSpPr>
        <p:spPr>
          <a:xfrm>
            <a:off x="7697181" y="1410519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2FAE24E-7CC6-9D40-994E-42F9EFE3966B}"/>
              </a:ext>
            </a:extLst>
          </p:cNvPr>
          <p:cNvSpPr txBox="1"/>
          <p:nvPr/>
        </p:nvSpPr>
        <p:spPr>
          <a:xfrm>
            <a:off x="7775727" y="159902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1747F42-1E89-8C47-BC1F-1F55EA93B768}"/>
              </a:ext>
            </a:extLst>
          </p:cNvPr>
          <p:cNvSpPr txBox="1"/>
          <p:nvPr/>
        </p:nvSpPr>
        <p:spPr>
          <a:xfrm>
            <a:off x="7752135" y="197783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8DD163B-0788-4340-A759-43571BA09A76}"/>
              </a:ext>
            </a:extLst>
          </p:cNvPr>
          <p:cNvSpPr txBox="1"/>
          <p:nvPr/>
        </p:nvSpPr>
        <p:spPr>
          <a:xfrm>
            <a:off x="7747123" y="224590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72BCBDE-8330-704A-A3B0-E5BB5D91493F}"/>
              </a:ext>
            </a:extLst>
          </p:cNvPr>
          <p:cNvSpPr txBox="1"/>
          <p:nvPr/>
        </p:nvSpPr>
        <p:spPr>
          <a:xfrm>
            <a:off x="3965372" y="562327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9B8E4D8-ED82-244B-888F-26D2BC7F2CDB}"/>
              </a:ext>
            </a:extLst>
          </p:cNvPr>
          <p:cNvSpPr txBox="1"/>
          <p:nvPr/>
        </p:nvSpPr>
        <p:spPr>
          <a:xfrm>
            <a:off x="3966070" y="583415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6712C6E-C53D-314E-AB1B-C18C366D97A2}"/>
              </a:ext>
            </a:extLst>
          </p:cNvPr>
          <p:cNvSpPr txBox="1"/>
          <p:nvPr/>
        </p:nvSpPr>
        <p:spPr>
          <a:xfrm>
            <a:off x="4044616" y="602266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C89FC2B-0611-8D4B-8502-41BADF3F4B0C}"/>
              </a:ext>
            </a:extLst>
          </p:cNvPr>
          <p:cNvSpPr txBox="1"/>
          <p:nvPr/>
        </p:nvSpPr>
        <p:spPr>
          <a:xfrm>
            <a:off x="4021024" y="640147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6D0689C-C6F2-CF43-B790-7301959DE801}"/>
              </a:ext>
            </a:extLst>
          </p:cNvPr>
          <p:cNvSpPr txBox="1"/>
          <p:nvPr/>
        </p:nvSpPr>
        <p:spPr>
          <a:xfrm>
            <a:off x="4016012" y="67638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6B56309-70CD-4D49-B356-70388BDB8C2C}"/>
              </a:ext>
            </a:extLst>
          </p:cNvPr>
          <p:cNvSpPr txBox="1"/>
          <p:nvPr/>
        </p:nvSpPr>
        <p:spPr>
          <a:xfrm>
            <a:off x="7673232" y="102817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4D3F4DA-F397-8A4E-A6D7-30DF040F394B}"/>
              </a:ext>
            </a:extLst>
          </p:cNvPr>
          <p:cNvSpPr txBox="1"/>
          <p:nvPr/>
        </p:nvSpPr>
        <p:spPr>
          <a:xfrm>
            <a:off x="3950580" y="545171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29EB41D-5CFD-7942-BC32-14BB9333FF45}"/>
              </a:ext>
            </a:extLst>
          </p:cNvPr>
          <p:cNvSpPr txBox="1"/>
          <p:nvPr/>
        </p:nvSpPr>
        <p:spPr>
          <a:xfrm>
            <a:off x="372675" y="368230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EA86A12-83BB-9A4C-97B6-605C386F110C}"/>
              </a:ext>
            </a:extLst>
          </p:cNvPr>
          <p:cNvSpPr txBox="1"/>
          <p:nvPr/>
        </p:nvSpPr>
        <p:spPr>
          <a:xfrm>
            <a:off x="373373" y="379433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553D105-68E2-EF4C-A130-34F84E9C498F}"/>
              </a:ext>
            </a:extLst>
          </p:cNvPr>
          <p:cNvSpPr txBox="1"/>
          <p:nvPr/>
        </p:nvSpPr>
        <p:spPr>
          <a:xfrm>
            <a:off x="451919" y="392517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0A630C3-90BD-844D-BC9B-7DC9EB6179C5}"/>
              </a:ext>
            </a:extLst>
          </p:cNvPr>
          <p:cNvSpPr txBox="1"/>
          <p:nvPr/>
        </p:nvSpPr>
        <p:spPr>
          <a:xfrm>
            <a:off x="428327" y="4147379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E9FFEB5-8D59-D141-903C-3F1BFCB98270}"/>
              </a:ext>
            </a:extLst>
          </p:cNvPr>
          <p:cNvSpPr txBox="1"/>
          <p:nvPr/>
        </p:nvSpPr>
        <p:spPr>
          <a:xfrm>
            <a:off x="389054" y="356651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224AF70-CC88-4747-A7AD-A63B4BEF10E5}"/>
              </a:ext>
            </a:extLst>
          </p:cNvPr>
          <p:cNvSpPr txBox="1"/>
          <p:nvPr/>
        </p:nvSpPr>
        <p:spPr>
          <a:xfrm>
            <a:off x="368527" y="6129085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45414D7-4833-A348-B212-01102A66D043}"/>
              </a:ext>
            </a:extLst>
          </p:cNvPr>
          <p:cNvSpPr txBox="1"/>
          <p:nvPr/>
        </p:nvSpPr>
        <p:spPr>
          <a:xfrm>
            <a:off x="369225" y="622079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304A09A-F59B-B14F-8F8C-13F3B06E5A8A}"/>
              </a:ext>
            </a:extLst>
          </p:cNvPr>
          <p:cNvSpPr txBox="1"/>
          <p:nvPr/>
        </p:nvSpPr>
        <p:spPr>
          <a:xfrm>
            <a:off x="447771" y="633131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09DD43E-96EB-184A-8754-C9AEBD06103B}"/>
              </a:ext>
            </a:extLst>
          </p:cNvPr>
          <p:cNvSpPr txBox="1"/>
          <p:nvPr/>
        </p:nvSpPr>
        <p:spPr>
          <a:xfrm>
            <a:off x="424179" y="655352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E9ED4B7-3354-FD49-85EC-4DD255197EB6}"/>
              </a:ext>
            </a:extLst>
          </p:cNvPr>
          <p:cNvSpPr txBox="1"/>
          <p:nvPr/>
        </p:nvSpPr>
        <p:spPr>
          <a:xfrm>
            <a:off x="371360" y="601329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D0703E5-4759-3847-97DE-1665CAADE631}"/>
              </a:ext>
            </a:extLst>
          </p:cNvPr>
          <p:cNvSpPr txBox="1"/>
          <p:nvPr/>
        </p:nvSpPr>
        <p:spPr>
          <a:xfrm>
            <a:off x="4108248" y="234414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C212B60-A51B-8641-A924-E09FC2E27690}"/>
              </a:ext>
            </a:extLst>
          </p:cNvPr>
          <p:cNvSpPr txBox="1"/>
          <p:nvPr/>
        </p:nvSpPr>
        <p:spPr>
          <a:xfrm>
            <a:off x="4108248" y="253488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-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A5010D20-532D-DA44-B04D-0C024D176F57}"/>
              </a:ext>
            </a:extLst>
          </p:cNvPr>
          <p:cNvSpPr txBox="1"/>
          <p:nvPr/>
        </p:nvSpPr>
        <p:spPr>
          <a:xfrm>
            <a:off x="4089706" y="280409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-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95B567B-580F-0443-8953-16AC18DB2AE6}"/>
              </a:ext>
            </a:extLst>
          </p:cNvPr>
          <p:cNvSpPr txBox="1"/>
          <p:nvPr/>
        </p:nvSpPr>
        <p:spPr>
          <a:xfrm>
            <a:off x="4064102" y="430059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629352E-DDDC-6C45-93D6-511C64788760}"/>
              </a:ext>
            </a:extLst>
          </p:cNvPr>
          <p:cNvSpPr txBox="1"/>
          <p:nvPr/>
        </p:nvSpPr>
        <p:spPr>
          <a:xfrm>
            <a:off x="4064102" y="447055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-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F5E181C-C19F-5141-A0AA-9B54AAD8EEA0}"/>
              </a:ext>
            </a:extLst>
          </p:cNvPr>
          <p:cNvSpPr txBox="1"/>
          <p:nvPr/>
        </p:nvSpPr>
        <p:spPr>
          <a:xfrm>
            <a:off x="4045560" y="464970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-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64BBB87-76DD-3748-8956-E79266D455E5}"/>
              </a:ext>
            </a:extLst>
          </p:cNvPr>
          <p:cNvSpPr txBox="1"/>
          <p:nvPr/>
        </p:nvSpPr>
        <p:spPr>
          <a:xfrm>
            <a:off x="7668705" y="497552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26BF80B-F653-644F-92FD-2B865C9D9806}"/>
              </a:ext>
            </a:extLst>
          </p:cNvPr>
          <p:cNvSpPr txBox="1"/>
          <p:nvPr/>
        </p:nvSpPr>
        <p:spPr>
          <a:xfrm>
            <a:off x="7669403" y="508755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646A33A-4D3E-5342-8B15-1C6D7DB9FF16}"/>
              </a:ext>
            </a:extLst>
          </p:cNvPr>
          <p:cNvSpPr txBox="1"/>
          <p:nvPr/>
        </p:nvSpPr>
        <p:spPr>
          <a:xfrm>
            <a:off x="7747949" y="518367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826C965-4870-2E48-9D93-E5B5EDB862CE}"/>
              </a:ext>
            </a:extLst>
          </p:cNvPr>
          <p:cNvSpPr txBox="1"/>
          <p:nvPr/>
        </p:nvSpPr>
        <p:spPr>
          <a:xfrm>
            <a:off x="7724357" y="534454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80EFDCE-B45C-FD4A-9F89-FB02952E1452}"/>
              </a:ext>
            </a:extLst>
          </p:cNvPr>
          <p:cNvSpPr txBox="1"/>
          <p:nvPr/>
        </p:nvSpPr>
        <p:spPr>
          <a:xfrm>
            <a:off x="7719345" y="5496859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DF6BB21-0A81-A841-8550-207E228ED667}"/>
              </a:ext>
            </a:extLst>
          </p:cNvPr>
          <p:cNvSpPr txBox="1"/>
          <p:nvPr/>
        </p:nvSpPr>
        <p:spPr>
          <a:xfrm>
            <a:off x="7729045" y="5767879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CF89C84-027C-F141-99CD-78956F2AE1C8}"/>
              </a:ext>
            </a:extLst>
          </p:cNvPr>
          <p:cNvSpPr txBox="1"/>
          <p:nvPr/>
        </p:nvSpPr>
        <p:spPr>
          <a:xfrm>
            <a:off x="7685084" y="487775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54394DAF-C8DF-C546-B33D-28B33C485B42}"/>
              </a:ext>
            </a:extLst>
          </p:cNvPr>
          <p:cNvSpPr txBox="1"/>
          <p:nvPr/>
        </p:nvSpPr>
        <p:spPr>
          <a:xfrm>
            <a:off x="7401335" y="689992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CB14247-B484-BF44-BD01-5266256784A0}"/>
              </a:ext>
            </a:extLst>
          </p:cNvPr>
          <p:cNvSpPr txBox="1"/>
          <p:nvPr/>
        </p:nvSpPr>
        <p:spPr>
          <a:xfrm>
            <a:off x="7402033" y="7011949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C682CA5-F9C5-9845-96B2-1D69A9CF8C7C}"/>
              </a:ext>
            </a:extLst>
          </p:cNvPr>
          <p:cNvSpPr txBox="1"/>
          <p:nvPr/>
        </p:nvSpPr>
        <p:spPr>
          <a:xfrm>
            <a:off x="7480579" y="710806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3DC003E-00C5-BF41-B43E-216F8D60DED8}"/>
              </a:ext>
            </a:extLst>
          </p:cNvPr>
          <p:cNvSpPr txBox="1"/>
          <p:nvPr/>
        </p:nvSpPr>
        <p:spPr>
          <a:xfrm>
            <a:off x="7456987" y="73579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A276065-9769-2544-972B-014AC1A25D89}"/>
              </a:ext>
            </a:extLst>
          </p:cNvPr>
          <p:cNvSpPr txBox="1"/>
          <p:nvPr/>
        </p:nvSpPr>
        <p:spPr>
          <a:xfrm>
            <a:off x="7451975" y="755881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085571F8-CA71-4049-AC59-903AF92149EE}"/>
              </a:ext>
            </a:extLst>
          </p:cNvPr>
          <p:cNvSpPr txBox="1"/>
          <p:nvPr/>
        </p:nvSpPr>
        <p:spPr>
          <a:xfrm>
            <a:off x="7413123" y="785411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2D22B07-295D-4A4A-ADA3-1EE6DD9A6F88}"/>
              </a:ext>
            </a:extLst>
          </p:cNvPr>
          <p:cNvSpPr txBox="1"/>
          <p:nvPr/>
        </p:nvSpPr>
        <p:spPr>
          <a:xfrm>
            <a:off x="7417714" y="680214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20EE7C74-375A-574C-BF03-04863D9FE52B}"/>
              </a:ext>
            </a:extLst>
          </p:cNvPr>
          <p:cNvCxnSpPr>
            <a:cxnSpLocks/>
          </p:cNvCxnSpPr>
          <p:nvPr/>
        </p:nvCxnSpPr>
        <p:spPr>
          <a:xfrm>
            <a:off x="776447" y="2254464"/>
            <a:ext cx="319855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26C8669E-AB03-E94B-9E1F-0FA10C4AA04C}"/>
              </a:ext>
            </a:extLst>
          </p:cNvPr>
          <p:cNvCxnSpPr>
            <a:cxnSpLocks/>
            <a:stCxn id="16" idx="1"/>
          </p:cNvCxnSpPr>
          <p:nvPr/>
        </p:nvCxnSpPr>
        <p:spPr>
          <a:xfrm flipV="1">
            <a:off x="724767" y="4649705"/>
            <a:ext cx="3019538" cy="12161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9F813D06-38DA-F041-BBFF-F18D36B508F4}"/>
              </a:ext>
            </a:extLst>
          </p:cNvPr>
          <p:cNvCxnSpPr>
            <a:cxnSpLocks/>
            <a:endCxn id="12" idx="3"/>
          </p:cNvCxnSpPr>
          <p:nvPr/>
        </p:nvCxnSpPr>
        <p:spPr>
          <a:xfrm>
            <a:off x="766822" y="7098945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636DE2A4-CF6D-614E-B412-B88904AFE1B3}"/>
              </a:ext>
            </a:extLst>
          </p:cNvPr>
          <p:cNvCxnSpPr>
            <a:cxnSpLocks/>
          </p:cNvCxnSpPr>
          <p:nvPr/>
        </p:nvCxnSpPr>
        <p:spPr>
          <a:xfrm>
            <a:off x="4432166" y="6152765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E1A8537B-C9F1-6648-838E-3C58CB28052F}"/>
              </a:ext>
            </a:extLst>
          </p:cNvPr>
          <p:cNvCxnSpPr>
            <a:cxnSpLocks/>
          </p:cNvCxnSpPr>
          <p:nvPr/>
        </p:nvCxnSpPr>
        <p:spPr>
          <a:xfrm>
            <a:off x="4371689" y="4210229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811E98C1-A334-9146-91FE-E466162DDE64}"/>
              </a:ext>
            </a:extLst>
          </p:cNvPr>
          <p:cNvCxnSpPr>
            <a:cxnSpLocks/>
          </p:cNvCxnSpPr>
          <p:nvPr/>
        </p:nvCxnSpPr>
        <p:spPr>
          <a:xfrm>
            <a:off x="4415810" y="2148390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90668608-8E64-0B42-861E-C14D947828C1}"/>
              </a:ext>
            </a:extLst>
          </p:cNvPr>
          <p:cNvCxnSpPr>
            <a:cxnSpLocks/>
          </p:cNvCxnSpPr>
          <p:nvPr/>
        </p:nvCxnSpPr>
        <p:spPr>
          <a:xfrm>
            <a:off x="8081484" y="1694260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EEC1E45F-17C6-BA4D-AB3E-94B81DF99A8B}"/>
              </a:ext>
            </a:extLst>
          </p:cNvPr>
          <p:cNvCxnSpPr>
            <a:cxnSpLocks/>
          </p:cNvCxnSpPr>
          <p:nvPr/>
        </p:nvCxnSpPr>
        <p:spPr>
          <a:xfrm>
            <a:off x="7969851" y="5717902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37228F6D-6253-0D44-992D-AD0EF396EF9F}"/>
              </a:ext>
            </a:extLst>
          </p:cNvPr>
          <p:cNvCxnSpPr>
            <a:cxnSpLocks/>
          </p:cNvCxnSpPr>
          <p:nvPr/>
        </p:nvCxnSpPr>
        <p:spPr>
          <a:xfrm>
            <a:off x="7775727" y="7805744"/>
            <a:ext cx="2937933" cy="737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29476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6</TotalTime>
  <Words>82</Words>
  <Application>Microsoft Office PowerPoint</Application>
  <PresentationFormat>Custom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celyn Chen</dc:creator>
  <cp:lastModifiedBy>Yan, Qin</cp:lastModifiedBy>
  <cp:revision>62</cp:revision>
  <dcterms:created xsi:type="dcterms:W3CDTF">2022-03-15T20:13:12Z</dcterms:created>
  <dcterms:modified xsi:type="dcterms:W3CDTF">2022-03-29T02:29:09Z</dcterms:modified>
</cp:coreProperties>
</file>